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  <a:srgbClr val="FF00FF"/>
    <a:srgbClr val="0000FF"/>
    <a:srgbClr val="800000"/>
    <a:srgbClr val="6600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858" autoAdjust="0"/>
    <p:restoredTop sz="86810" autoAdjust="0"/>
  </p:normalViewPr>
  <p:slideViewPr>
    <p:cSldViewPr>
      <p:cViewPr varScale="1">
        <p:scale>
          <a:sx n="73" d="100"/>
          <a:sy n="73" d="100"/>
        </p:scale>
        <p:origin x="2274" y="5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cygwin\home\fuku\work\analysis\transcriptome\f-purpurea\eval\BasicStatistics\kegg_summ2b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4"/>
    </mc:Choice>
    <mc:Fallback>
      <c:style val="4"/>
    </mc:Fallback>
  </mc:AlternateContent>
  <c:chart>
    <c:autoTitleDeleted val="0"/>
    <c:plotArea>
      <c:layout/>
      <c:barChart>
        <c:barDir val="bar"/>
        <c:grouping val="clustered"/>
        <c:varyColors val="0"/>
        <c:ser>
          <c:idx val="0"/>
          <c:order val="0"/>
          <c:invertIfNegative val="0"/>
          <c:cat>
            <c:strRef>
              <c:f>kegg_summ2!$A$111:$A$140</c:f>
              <c:strCache>
                <c:ptCount val="30"/>
                <c:pt idx="0">
                  <c:v>Propanoate metabolism</c:v>
                </c:pt>
                <c:pt idx="1">
                  <c:v>Carbon fixation pathways in prokaryotes</c:v>
                </c:pt>
                <c:pt idx="2">
                  <c:v>Terpenoid backbone biosynthesis</c:v>
                </c:pt>
                <c:pt idx="3">
                  <c:v>Ascorbate and aldarate metabolism</c:v>
                </c:pt>
                <c:pt idx="4">
                  <c:v>Diterpenoid biosynthesis</c:v>
                </c:pt>
                <c:pt idx="5">
                  <c:v>Pentose phosphate pathway</c:v>
                </c:pt>
                <c:pt idx="6">
                  <c:v>Nicotinate and nicotinamide metabolism</c:v>
                </c:pt>
                <c:pt idx="7">
                  <c:v>Lysine degradation</c:v>
                </c:pt>
                <c:pt idx="8">
                  <c:v>Butanoate metabolism</c:v>
                </c:pt>
                <c:pt idx="9">
                  <c:v>Isoquinoline alkaloid biosynthesis</c:v>
                </c:pt>
                <c:pt idx="10">
                  <c:v>Glycerophospholipid metabolism</c:v>
                </c:pt>
                <c:pt idx="11">
                  <c:v>Pentose and glucuronate interconversions</c:v>
                </c:pt>
                <c:pt idx="12">
                  <c:v>Aminobenzoate degradation</c:v>
                </c:pt>
                <c:pt idx="13">
                  <c:v>Glycine, serine and threonine metabolism</c:v>
                </c:pt>
                <c:pt idx="14">
                  <c:v>Pyruvate metabolism</c:v>
                </c:pt>
                <c:pt idx="15">
                  <c:v>Benzoate degradation</c:v>
                </c:pt>
                <c:pt idx="16">
                  <c:v>Pyrimidine metabolism</c:v>
                </c:pt>
                <c:pt idx="17">
                  <c:v>Glyoxylate and dicarboxylate metabolism</c:v>
                </c:pt>
                <c:pt idx="18">
                  <c:v>Tyrosine metabolism</c:v>
                </c:pt>
                <c:pt idx="19">
                  <c:v>Fructose and mannose metabolism</c:v>
                </c:pt>
                <c:pt idx="20">
                  <c:v>Cysteine and methionine metabolism</c:v>
                </c:pt>
                <c:pt idx="21">
                  <c:v>Phenylalanine metabolism</c:v>
                </c:pt>
                <c:pt idx="22">
                  <c:v>Tryptophan metabolism</c:v>
                </c:pt>
                <c:pt idx="23">
                  <c:v>Starch and sucrose metabolism</c:v>
                </c:pt>
                <c:pt idx="24">
                  <c:v>Sesquiterpenoid and triterpenoid biosynthesis</c:v>
                </c:pt>
                <c:pt idx="25">
                  <c:v>Methane metabolism</c:v>
                </c:pt>
                <c:pt idx="26">
                  <c:v>Porphyrin and chlorophyll metabolism</c:v>
                </c:pt>
                <c:pt idx="27">
                  <c:v>Arginine and proline metabolism</c:v>
                </c:pt>
                <c:pt idx="28">
                  <c:v>Purine metabolism</c:v>
                </c:pt>
                <c:pt idx="29">
                  <c:v>Amino sugar and nucleotide sugar metabolism</c:v>
                </c:pt>
              </c:strCache>
            </c:strRef>
          </c:cat>
          <c:val>
            <c:numRef>
              <c:f>kegg_summ2!$B$111:$B$140</c:f>
              <c:numCache>
                <c:formatCode>General</c:formatCode>
                <c:ptCount val="30"/>
                <c:pt idx="0">
                  <c:v>46</c:v>
                </c:pt>
                <c:pt idx="1">
                  <c:v>47</c:v>
                </c:pt>
                <c:pt idx="2">
                  <c:v>47</c:v>
                </c:pt>
                <c:pt idx="3">
                  <c:v>48</c:v>
                </c:pt>
                <c:pt idx="4">
                  <c:v>50</c:v>
                </c:pt>
                <c:pt idx="5">
                  <c:v>50</c:v>
                </c:pt>
                <c:pt idx="6">
                  <c:v>52</c:v>
                </c:pt>
                <c:pt idx="7">
                  <c:v>55</c:v>
                </c:pt>
                <c:pt idx="8">
                  <c:v>56</c:v>
                </c:pt>
                <c:pt idx="9">
                  <c:v>57</c:v>
                </c:pt>
                <c:pt idx="10">
                  <c:v>62</c:v>
                </c:pt>
                <c:pt idx="11">
                  <c:v>63</c:v>
                </c:pt>
                <c:pt idx="12">
                  <c:v>64</c:v>
                </c:pt>
                <c:pt idx="13">
                  <c:v>64</c:v>
                </c:pt>
                <c:pt idx="14">
                  <c:v>64</c:v>
                </c:pt>
                <c:pt idx="15">
                  <c:v>66</c:v>
                </c:pt>
                <c:pt idx="16">
                  <c:v>66</c:v>
                </c:pt>
                <c:pt idx="17">
                  <c:v>67</c:v>
                </c:pt>
                <c:pt idx="18">
                  <c:v>67</c:v>
                </c:pt>
                <c:pt idx="19">
                  <c:v>68</c:v>
                </c:pt>
                <c:pt idx="20">
                  <c:v>69</c:v>
                </c:pt>
                <c:pt idx="21">
                  <c:v>70</c:v>
                </c:pt>
                <c:pt idx="22">
                  <c:v>73</c:v>
                </c:pt>
                <c:pt idx="23">
                  <c:v>74</c:v>
                </c:pt>
                <c:pt idx="24">
                  <c:v>78</c:v>
                </c:pt>
                <c:pt idx="25">
                  <c:v>81</c:v>
                </c:pt>
                <c:pt idx="26">
                  <c:v>83</c:v>
                </c:pt>
                <c:pt idx="27">
                  <c:v>107</c:v>
                </c:pt>
                <c:pt idx="28">
                  <c:v>108</c:v>
                </c:pt>
                <c:pt idx="29">
                  <c:v>10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23001824"/>
        <c:axId val="323002216"/>
      </c:barChart>
      <c:catAx>
        <c:axId val="323001824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crossAx val="323002216"/>
        <c:crosses val="autoZero"/>
        <c:auto val="1"/>
        <c:lblAlgn val="ctr"/>
        <c:lblOffset val="100"/>
        <c:noMultiLvlLbl val="0"/>
      </c:catAx>
      <c:valAx>
        <c:axId val="323002216"/>
        <c:scaling>
          <c:orientation val="minMax"/>
        </c:scaling>
        <c:delete val="0"/>
        <c:axPos val="b"/>
        <c:majorGridlines/>
        <c:numFmt formatCode="General" sourceLinked="1"/>
        <c:majorTickMark val="out"/>
        <c:minorTickMark val="none"/>
        <c:tickLblPos val="nextTo"/>
        <c:crossAx val="32300182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F5CF5F0-A185-432C-82C1-DB1F4BB881D7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368D9E-EFE5-4006-9788-5123A72728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42513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4 Fig. Pathway enrichment analysis of assembled </a:t>
            </a:r>
            <a:r>
              <a:rPr kumimoji="1" lang="en-US" altLang="ja-JP" sz="12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igenes</a:t>
            </a:r>
            <a:r>
              <a:rPr kumimoji="1" lang="en-US" altLang="ja-JP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green </a:t>
            </a:r>
            <a:r>
              <a:rPr kumimoji="1" lang="en-US" altLang="ja-JP" sz="12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rilla</a:t>
            </a:r>
            <a:r>
              <a:rPr kumimoji="1" lang="en-US" altLang="ja-JP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notated </a:t>
            </a:r>
            <a:r>
              <a:rPr kumimoji="1" lang="en-US" altLang="ja-JP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igenes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ere grouped into 137 KEGG pathways. The top 30 pathways containing </a:t>
            </a:r>
            <a:r>
              <a:rPr kumimoji="1" lang="en-US" altLang="ja-JP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igenes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re displayed.</a:t>
            </a:r>
            <a:endParaRPr kumimoji="1" lang="ja-JP" altLang="ja-JP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F368D9E-EFE5-4006-9788-5123A727280B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55425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/>
          <p:cNvSpPr txBox="1"/>
          <p:nvPr/>
        </p:nvSpPr>
        <p:spPr>
          <a:xfrm>
            <a:off x="3222473" y="6750399"/>
            <a:ext cx="1415101" cy="226893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umber of </a:t>
            </a:r>
            <a:r>
              <a:rPr lang="en-US" altLang="ja-JP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igene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グラフ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01217176"/>
              </p:ext>
            </p:extLst>
          </p:nvPr>
        </p:nvGraphicFramePr>
        <p:xfrm>
          <a:off x="1052736" y="1072679"/>
          <a:ext cx="4572000" cy="58293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2132856" y="8774668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Fukushima et al. S4 Fig.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72346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25</TotalTime>
  <Words>42</Words>
  <Application>Microsoft Office PowerPoint</Application>
  <PresentationFormat>画面に合わせる (4:3)</PresentationFormat>
  <Paragraphs>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uku</dc:creator>
  <cp:lastModifiedBy>fuku</cp:lastModifiedBy>
  <cp:revision>181</cp:revision>
  <dcterms:created xsi:type="dcterms:W3CDTF">2014-12-01T05:59:03Z</dcterms:created>
  <dcterms:modified xsi:type="dcterms:W3CDTF">2015-05-12T04:00:10Z</dcterms:modified>
</cp:coreProperties>
</file>